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 autoAdjust="0"/>
    <p:restoredTop sz="94684" autoAdjust="0"/>
  </p:normalViewPr>
  <p:slideViewPr>
    <p:cSldViewPr>
      <p:cViewPr varScale="1">
        <p:scale>
          <a:sx n="75" d="100"/>
          <a:sy n="75" d="100"/>
        </p:scale>
        <p:origin x="-882" y="-9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F4ED2-38B7-400F-A358-6357BCCCCAE7}" type="datetimeFigureOut">
              <a:rPr lang="en-US" smtClean="0"/>
              <a:pPr/>
              <a:t>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49C7B-CE89-419D-9EDC-28C936A4A82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Group 87"/>
          <p:cNvGrpSpPr/>
          <p:nvPr/>
        </p:nvGrpSpPr>
        <p:grpSpPr>
          <a:xfrm>
            <a:off x="152399" y="164068"/>
            <a:ext cx="9372601" cy="6684406"/>
            <a:chOff x="152399" y="164068"/>
            <a:chExt cx="9372601" cy="6684406"/>
          </a:xfrm>
        </p:grpSpPr>
        <p:grpSp>
          <p:nvGrpSpPr>
            <p:cNvPr id="13" name="Group 12"/>
            <p:cNvGrpSpPr/>
            <p:nvPr/>
          </p:nvGrpSpPr>
          <p:grpSpPr>
            <a:xfrm>
              <a:off x="152399" y="164068"/>
              <a:ext cx="9372601" cy="6684406"/>
              <a:chOff x="152399" y="164068"/>
              <a:chExt cx="9372601" cy="6684406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 rot="16200000">
                <a:off x="1865819" y="-810707"/>
                <a:ext cx="5945761" cy="93726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381000" y="164068"/>
                <a:ext cx="890314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Fig. S2. The optimal structure of the MCDV leader predicted by the GCG MFOLD</a:t>
                </a:r>
              </a:p>
              <a:p>
                <a:r>
                  <a:rPr lang="en-US" dirty="0" smtClean="0"/>
                  <a:t>(with positions of the </a:t>
                </a:r>
                <a:r>
                  <a:rPr lang="en-US" dirty="0" err="1" smtClean="0"/>
                  <a:t>sORF</a:t>
                </a:r>
                <a:r>
                  <a:rPr lang="en-US" dirty="0" smtClean="0"/>
                  <a:t> start and stop </a:t>
                </a:r>
                <a:r>
                  <a:rPr lang="en-US" dirty="0" err="1" smtClean="0"/>
                  <a:t>codons</a:t>
                </a:r>
                <a:r>
                  <a:rPr lang="en-US" dirty="0" smtClean="0"/>
                  <a:t> indicated in red and green, respectively)   </a:t>
                </a:r>
                <a:endParaRPr lang="en-US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133600" y="3171822"/>
                <a:ext cx="25199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FF0000"/>
                    </a:solidFill>
                  </a:rPr>
                  <a:t>A</a:t>
                </a:r>
                <a:endParaRPr lang="en-US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071705" y="3133710"/>
                <a:ext cx="25840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FF0000"/>
                    </a:solidFill>
                  </a:rPr>
                  <a:t>U</a:t>
                </a:r>
                <a:endParaRPr lang="en-US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995489" y="3143244"/>
                <a:ext cx="25680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FF0000"/>
                    </a:solidFill>
                  </a:rPr>
                  <a:t>G</a:t>
                </a:r>
                <a:endParaRPr lang="en-US" sz="9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47689" y="3409948"/>
                <a:ext cx="258404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00B050"/>
                    </a:solidFill>
                  </a:rPr>
                  <a:t>U</a:t>
                </a:r>
                <a:endParaRPr lang="en-US" sz="9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81022" y="3176593"/>
                <a:ext cx="25680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00B050"/>
                    </a:solidFill>
                  </a:rPr>
                  <a:t>G</a:t>
                </a:r>
                <a:endParaRPr lang="en-US" sz="9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14348" y="3276600"/>
                <a:ext cx="251992" cy="2308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solidFill>
                      <a:srgbClr val="00B050"/>
                    </a:solidFill>
                  </a:rPr>
                  <a:t>A</a:t>
                </a:r>
                <a:endParaRPr lang="en-US" sz="9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1295400" y="3581400"/>
                <a:ext cx="583814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 smtClean="0">
                    <a:solidFill>
                      <a:srgbClr val="FF0000"/>
                    </a:solidFill>
                  </a:rPr>
                  <a:t>sORF1</a:t>
                </a:r>
                <a:endParaRPr lang="en-US" sz="1200" b="1" i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 rot="2590751">
              <a:off x="2594335" y="3615821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10</a:t>
              </a:r>
              <a:endParaRPr lang="en-US" sz="7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3445271">
              <a:off x="2040716" y="3480744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0</a:t>
              </a:r>
              <a:endParaRPr lang="en-US" sz="7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204373">
              <a:off x="2369143" y="3173637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40</a:t>
              </a:r>
              <a:endParaRPr lang="en-US" sz="700" b="1" dirty="0"/>
            </a:p>
          </p:txBody>
        </p:sp>
        <p:sp>
          <p:nvSpPr>
            <p:cNvPr id="17" name="Oval 16"/>
            <p:cNvSpPr/>
            <p:nvPr/>
          </p:nvSpPr>
          <p:spPr>
            <a:xfrm rot="1064059">
              <a:off x="3538533" y="3429000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 rot="6370162">
              <a:off x="3202594" y="3336671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440</a:t>
              </a:r>
              <a:endParaRPr lang="en-US" sz="7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 rot="7743913">
              <a:off x="3943273" y="3967371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420</a:t>
              </a:r>
              <a:endParaRPr lang="en-US" sz="700" b="1" dirty="0"/>
            </a:p>
          </p:txBody>
        </p:sp>
        <p:sp>
          <p:nvSpPr>
            <p:cNvPr id="20" name="Oval 19"/>
            <p:cNvSpPr/>
            <p:nvPr/>
          </p:nvSpPr>
          <p:spPr>
            <a:xfrm rot="1064059">
              <a:off x="5746196" y="3599179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7890576">
              <a:off x="4190571" y="3439774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410</a:t>
              </a:r>
              <a:endParaRPr lang="en-US" sz="7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 rot="3601511">
              <a:off x="4864505" y="3431525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380</a:t>
              </a:r>
              <a:endParaRPr lang="en-US" sz="700" b="1" dirty="0"/>
            </a:p>
          </p:txBody>
        </p:sp>
        <p:sp>
          <p:nvSpPr>
            <p:cNvPr id="23" name="Oval 22"/>
            <p:cNvSpPr/>
            <p:nvPr/>
          </p:nvSpPr>
          <p:spPr>
            <a:xfrm rot="826671">
              <a:off x="3928150" y="3142512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4" name="Oval 23"/>
            <p:cNvSpPr/>
            <p:nvPr/>
          </p:nvSpPr>
          <p:spPr>
            <a:xfrm rot="20844462">
              <a:off x="6249614" y="3671464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 rot="5212687">
              <a:off x="7016213" y="3936348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350</a:t>
              </a:r>
              <a:endParaRPr lang="en-US" sz="700" b="1" dirty="0"/>
            </a:p>
          </p:txBody>
        </p:sp>
        <p:sp>
          <p:nvSpPr>
            <p:cNvPr id="26" name="Oval 25"/>
            <p:cNvSpPr/>
            <p:nvPr/>
          </p:nvSpPr>
          <p:spPr>
            <a:xfrm rot="15624785">
              <a:off x="7581176" y="4457278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7" name="TextBox 26"/>
            <p:cNvSpPr txBox="1"/>
            <p:nvPr/>
          </p:nvSpPr>
          <p:spPr>
            <a:xfrm rot="9923375">
              <a:off x="7611499" y="5066238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330</a:t>
              </a:r>
              <a:endParaRPr lang="en-US" sz="700" b="1" dirty="0"/>
            </a:p>
          </p:txBody>
        </p:sp>
        <p:sp>
          <p:nvSpPr>
            <p:cNvPr id="28" name="Oval 27"/>
            <p:cNvSpPr/>
            <p:nvPr/>
          </p:nvSpPr>
          <p:spPr>
            <a:xfrm rot="15624785">
              <a:off x="7973994" y="5737731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487787" y="5966358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310</a:t>
              </a:r>
              <a:endParaRPr lang="en-US" sz="700" b="1" dirty="0"/>
            </a:p>
          </p:txBody>
        </p:sp>
        <p:sp>
          <p:nvSpPr>
            <p:cNvPr id="30" name="Oval 29"/>
            <p:cNvSpPr/>
            <p:nvPr/>
          </p:nvSpPr>
          <p:spPr>
            <a:xfrm rot="16200000">
              <a:off x="8326417" y="5280539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066349">
              <a:off x="8158804" y="4799465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90</a:t>
              </a:r>
              <a:endParaRPr lang="en-US" sz="700" b="1" dirty="0"/>
            </a:p>
          </p:txBody>
        </p:sp>
        <p:sp>
          <p:nvSpPr>
            <p:cNvPr id="32" name="Oval 31"/>
            <p:cNvSpPr/>
            <p:nvPr/>
          </p:nvSpPr>
          <p:spPr>
            <a:xfrm rot="15063251">
              <a:off x="7920528" y="3991324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3" name="TextBox 32"/>
            <p:cNvSpPr txBox="1"/>
            <p:nvPr/>
          </p:nvSpPr>
          <p:spPr>
            <a:xfrm rot="418072">
              <a:off x="8277222" y="3600452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70</a:t>
              </a:r>
              <a:endParaRPr lang="en-US" sz="700" b="1" dirty="0"/>
            </a:p>
          </p:txBody>
        </p:sp>
        <p:sp>
          <p:nvSpPr>
            <p:cNvPr id="34" name="Oval 33"/>
            <p:cNvSpPr/>
            <p:nvPr/>
          </p:nvSpPr>
          <p:spPr>
            <a:xfrm rot="17960076">
              <a:off x="7867151" y="3347683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5" name="TextBox 34"/>
            <p:cNvSpPr txBox="1"/>
            <p:nvPr/>
          </p:nvSpPr>
          <p:spPr>
            <a:xfrm rot="17453289">
              <a:off x="7229720" y="3475706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50</a:t>
              </a:r>
              <a:endParaRPr lang="en-US" sz="700" b="1" dirty="0"/>
            </a:p>
          </p:txBody>
        </p:sp>
        <p:sp>
          <p:nvSpPr>
            <p:cNvPr id="36" name="Oval 35"/>
            <p:cNvSpPr/>
            <p:nvPr/>
          </p:nvSpPr>
          <p:spPr>
            <a:xfrm rot="1610438">
              <a:off x="6406102" y="3298692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TextBox 36"/>
            <p:cNvSpPr txBox="1"/>
            <p:nvPr/>
          </p:nvSpPr>
          <p:spPr>
            <a:xfrm rot="19114642">
              <a:off x="5643801" y="3080418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30</a:t>
              </a:r>
              <a:endParaRPr lang="en-US" sz="700" b="1" dirty="0"/>
            </a:p>
          </p:txBody>
        </p:sp>
        <p:sp>
          <p:nvSpPr>
            <p:cNvPr id="38" name="Oval 37"/>
            <p:cNvSpPr/>
            <p:nvPr/>
          </p:nvSpPr>
          <p:spPr>
            <a:xfrm rot="21066538">
              <a:off x="4786842" y="2917691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Oval 38"/>
            <p:cNvSpPr/>
            <p:nvPr/>
          </p:nvSpPr>
          <p:spPr>
            <a:xfrm rot="5400000">
              <a:off x="3933062" y="2796500"/>
              <a:ext cx="178441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" name="Oval 40"/>
            <p:cNvSpPr/>
            <p:nvPr/>
          </p:nvSpPr>
          <p:spPr>
            <a:xfrm rot="3459378">
              <a:off x="3723980" y="2513547"/>
              <a:ext cx="120006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9254160">
              <a:off x="3597476" y="2543844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190</a:t>
              </a:r>
              <a:endParaRPr lang="en-US" sz="7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 rot="16453809">
              <a:off x="4593485" y="1147401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170</a:t>
              </a:r>
              <a:endParaRPr lang="en-US" sz="700" b="1" dirty="0"/>
            </a:p>
          </p:txBody>
        </p:sp>
        <p:sp>
          <p:nvSpPr>
            <p:cNvPr id="44" name="Oval 43"/>
            <p:cNvSpPr/>
            <p:nvPr/>
          </p:nvSpPr>
          <p:spPr>
            <a:xfrm rot="15733725">
              <a:off x="4012491" y="1763004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5" name="Oval 44"/>
            <p:cNvSpPr/>
            <p:nvPr/>
          </p:nvSpPr>
          <p:spPr>
            <a:xfrm rot="7472526">
              <a:off x="4252157" y="2070677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8424744">
              <a:off x="3859425" y="2817278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210</a:t>
              </a:r>
              <a:endParaRPr lang="en-US" sz="700" b="1" dirty="0"/>
            </a:p>
          </p:txBody>
        </p:sp>
        <p:sp>
          <p:nvSpPr>
            <p:cNvPr id="48" name="Oval 47"/>
            <p:cNvSpPr/>
            <p:nvPr/>
          </p:nvSpPr>
          <p:spPr>
            <a:xfrm rot="19161964">
              <a:off x="2993772" y="2345993"/>
              <a:ext cx="134411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9" name="TextBox 48"/>
            <p:cNvSpPr txBox="1"/>
            <p:nvPr/>
          </p:nvSpPr>
          <p:spPr>
            <a:xfrm rot="8936231">
              <a:off x="2957651" y="2373392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130</a:t>
              </a:r>
              <a:endParaRPr lang="en-US" sz="700" b="1" dirty="0"/>
            </a:p>
          </p:txBody>
        </p:sp>
        <p:sp>
          <p:nvSpPr>
            <p:cNvPr id="50" name="Oval 49"/>
            <p:cNvSpPr/>
            <p:nvPr/>
          </p:nvSpPr>
          <p:spPr>
            <a:xfrm rot="766793">
              <a:off x="2702802" y="1991603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1" name="TextBox 50"/>
            <p:cNvSpPr txBox="1"/>
            <p:nvPr/>
          </p:nvSpPr>
          <p:spPr>
            <a:xfrm rot="13238112">
              <a:off x="1733059" y="1600117"/>
              <a:ext cx="31931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110</a:t>
              </a:r>
              <a:endParaRPr lang="en-US" sz="700" b="1" dirty="0"/>
            </a:p>
          </p:txBody>
        </p:sp>
        <p:sp>
          <p:nvSpPr>
            <p:cNvPr id="52" name="Oval 51"/>
            <p:cNvSpPr/>
            <p:nvPr/>
          </p:nvSpPr>
          <p:spPr>
            <a:xfrm rot="766793">
              <a:off x="2491203" y="2400560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3" name="TextBox 52"/>
            <p:cNvSpPr txBox="1"/>
            <p:nvPr/>
          </p:nvSpPr>
          <p:spPr>
            <a:xfrm rot="14075386">
              <a:off x="2309815" y="2431967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90</a:t>
              </a:r>
              <a:endParaRPr lang="en-US" sz="700" b="1" dirty="0"/>
            </a:p>
          </p:txBody>
        </p:sp>
        <p:sp>
          <p:nvSpPr>
            <p:cNvPr id="54" name="Oval 53"/>
            <p:cNvSpPr/>
            <p:nvPr/>
          </p:nvSpPr>
          <p:spPr>
            <a:xfrm rot="20285632">
              <a:off x="2328448" y="2757225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5" name="TextBox 54"/>
            <p:cNvSpPr txBox="1"/>
            <p:nvPr/>
          </p:nvSpPr>
          <p:spPr>
            <a:xfrm rot="15524547">
              <a:off x="1435098" y="2925787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70</a:t>
              </a:r>
              <a:endParaRPr lang="en-US" sz="700" b="1" dirty="0"/>
            </a:p>
          </p:txBody>
        </p:sp>
        <p:sp>
          <p:nvSpPr>
            <p:cNvPr id="56" name="Oval 55"/>
            <p:cNvSpPr/>
            <p:nvPr/>
          </p:nvSpPr>
          <p:spPr>
            <a:xfrm rot="18450605">
              <a:off x="680075" y="3068177"/>
              <a:ext cx="152400" cy="2286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 rot="5570723">
              <a:off x="1426841" y="3415559"/>
              <a:ext cx="27443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50</a:t>
              </a:r>
              <a:endParaRPr lang="en-US" sz="700" b="1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533676" y="2471733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164705">
              <a:off x="2620951" y="2495532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20999765">
              <a:off x="2688418" y="2562198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 rot="1627467">
              <a:off x="2199320" y="1592180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rot="20109541">
              <a:off x="1886363" y="1609718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21434314">
              <a:off x="2036030" y="1550846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5172090">
              <a:off x="3391433" y="2220366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U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4901824">
              <a:off x="3325536" y="2310847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G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4336728">
              <a:off x="3375555" y="2138092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5400000">
              <a:off x="3309941" y="2428866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A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7743071">
              <a:off x="8166635" y="3634679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9242259">
              <a:off x="8078912" y="3682293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9995730">
              <a:off x="7986163" y="3672767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4358440">
              <a:off x="7891614" y="5276623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A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 rot="15073491">
              <a:off x="7909988" y="5352815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A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 rot="15073491">
              <a:off x="7931145" y="5438533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00B050"/>
                  </a:solidFill>
                </a:rPr>
                <a:t>U</a:t>
              </a:r>
              <a:endParaRPr lang="en-US" sz="900" dirty="0">
                <a:solidFill>
                  <a:srgbClr val="00B050"/>
                </a:solidFill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924050" y="2438400"/>
              <a:ext cx="551754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smtClean="0"/>
                <a:t>sORF2</a:t>
              </a:r>
              <a:endParaRPr lang="en-US" sz="1050" b="1" i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336576" y="1524000"/>
              <a:ext cx="534121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smtClean="0"/>
                <a:t>sORF3</a:t>
              </a:r>
              <a:endParaRPr lang="en-US" sz="1050" b="1" i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327176" y="1902768"/>
              <a:ext cx="534121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smtClean="0"/>
                <a:t>sORF4</a:t>
              </a:r>
              <a:endParaRPr lang="en-US" sz="1050" b="1" i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8077200" y="3962400"/>
              <a:ext cx="534121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smtClean="0"/>
                <a:t>sORF5</a:t>
              </a:r>
              <a:endParaRPr lang="en-US" sz="1050" b="1" i="1" dirty="0"/>
            </a:p>
          </p:txBody>
        </p:sp>
        <p:sp>
          <p:nvSpPr>
            <p:cNvPr id="79" name="TextBox 78"/>
            <p:cNvSpPr txBox="1"/>
            <p:nvPr/>
          </p:nvSpPr>
          <p:spPr>
            <a:xfrm rot="3100941">
              <a:off x="3630986" y="3040638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3100941">
              <a:off x="3675394" y="3078734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 rot="3100941">
              <a:off x="3757150" y="3105515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860576" y="3198168"/>
              <a:ext cx="534121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smtClean="0"/>
                <a:t>sORF6</a:t>
              </a:r>
              <a:endParaRPr lang="en-US" sz="1050" b="1" i="1" dirty="0"/>
            </a:p>
          </p:txBody>
        </p:sp>
        <p:sp>
          <p:nvSpPr>
            <p:cNvPr id="83" name="TextBox 82"/>
            <p:cNvSpPr txBox="1"/>
            <p:nvPr/>
          </p:nvSpPr>
          <p:spPr>
            <a:xfrm rot="14097675">
              <a:off x="3742285" y="3552282"/>
              <a:ext cx="25199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A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 rot="14097675">
              <a:off x="3666361" y="3473483"/>
              <a:ext cx="25840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U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 rot="14097675">
              <a:off x="3583581" y="3389186"/>
              <a:ext cx="256802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solidFill>
                    <a:srgbClr val="FF0000"/>
                  </a:solidFill>
                </a:rPr>
                <a:t>G</a:t>
              </a:r>
              <a:endParaRPr lang="en-US" sz="900" dirty="0">
                <a:solidFill>
                  <a:srgbClr val="FF0000"/>
                </a:solidFill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429000" y="3745468"/>
              <a:ext cx="859531" cy="41549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050" b="1" i="1" dirty="0" err="1" smtClean="0"/>
                <a:t>Polyprotein</a:t>
              </a:r>
              <a:r>
                <a:rPr lang="en-US" sz="1050" b="1" i="1" dirty="0" smtClean="0"/>
                <a:t> </a:t>
              </a:r>
            </a:p>
            <a:p>
              <a:r>
                <a:rPr lang="en-US" sz="1050" b="1" i="1" dirty="0" smtClean="0"/>
                <a:t>ORF</a:t>
              </a:r>
              <a:endParaRPr lang="en-US" sz="1050" b="1" i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3</TotalTime>
  <Words>92</Words>
  <Application>Microsoft Office PowerPoint</Application>
  <PresentationFormat>A4 Paper (210x297 mm)</PresentationFormat>
  <Paragraphs>6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ster</dc:creator>
  <cp:lastModifiedBy>master</cp:lastModifiedBy>
  <cp:revision>35</cp:revision>
  <dcterms:created xsi:type="dcterms:W3CDTF">2011-08-22T13:19:18Z</dcterms:created>
  <dcterms:modified xsi:type="dcterms:W3CDTF">2012-01-27T10:38:57Z</dcterms:modified>
</cp:coreProperties>
</file>